
<file path=[Content_Types].xml><?xml version="1.0" encoding="utf-8"?>
<Types xmlns="http://schemas.openxmlformats.org/package/2006/content-types"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6.xml"/>
  <Override ContentType="application/vnd.openxmlformats-officedocument.presentationml.slide+xml" PartName="/ppt/slides/slide5.xml"/>
  <Override ContentType="application/vnd.openxmlformats-officedocument.presentationml.slide+xml" PartName="/ppt/slides/slide8.xml"/>
  <Override ContentType="application/vnd.openxmlformats-officedocument.presentationml.slide+xml" PartName="/ppt/slides/slide7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5"/>
  </p:sldMasterIdLst>
  <p:notesMasterIdLst>
    <p:notesMasterId r:id="rId6"/>
  </p:notesMasterIdLst>
  <p:sldIdLst>
    <p:sldId id="256" r:id="rId7"/>
    <p:sldId id="257" r:id="rId8"/>
    <p:sldId id="258" r:id="rId9"/>
    <p:sldId id="259" r:id="rId10"/>
    <p:sldId id="260" r:id="rId11"/>
    <p:sldId id="261" r:id="rId12"/>
    <p:sldId id="262" r:id="rId13"/>
    <p:sldId id="263" r:id="rId14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CB56DA76-8842-4CF5-BA3B-0775C3941FC7}">
  <a:tblStyle styleId="{CB56DA76-8842-4CF5-BA3B-0775C3941FC7}" styleName="Table_0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1" Type="http://schemas.openxmlformats.org/officeDocument/2006/relationships/slide" Target="slides/slide5.xml"/><Relationship Id="rId10" Type="http://schemas.openxmlformats.org/officeDocument/2006/relationships/slide" Target="slides/slide4.xml"/><Relationship Id="rId13" Type="http://schemas.openxmlformats.org/officeDocument/2006/relationships/slide" Target="slides/slide7.xml"/><Relationship Id="rId12" Type="http://schemas.openxmlformats.org/officeDocument/2006/relationships/slide" Target="slides/slide6.xml"/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tableStyles" Target="tableStyles.xml"/><Relationship Id="rId9" Type="http://schemas.openxmlformats.org/officeDocument/2006/relationships/slide" Target="slides/slide3.xml"/><Relationship Id="rId14" Type="http://schemas.openxmlformats.org/officeDocument/2006/relationships/slide" Target="slides/slide8.xml"/><Relationship Id="rId5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Relationship Id="rId8" Type="http://schemas.openxmlformats.org/officeDocument/2006/relationships/slide" Target="slides/slide2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13ccaf29282_0_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13ccaf29282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3ccaf29282_0_1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13ccaf29282_0_1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2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13ccaf29282_0_5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13ccaf29282_0_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3ccaf29282_0_1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3ccaf29282_0_1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g13ccaf29282_0_3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6" name="Google Shape;76;g13ccaf29282_0_3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13ccaf29282_0_3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2" name="Google Shape;82;g13ccaf29282_0_3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6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g13ccaf29282_0_4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8" name="Google Shape;88;g13ccaf29282_0_4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2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g13ccaf29282_0_4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4" name="Google Shape;94;g13ccaf29282_0_4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4.xml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5.xml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6.xml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7.xml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8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 fontScale="90000"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Top 20 First 10 Neoplasia</a:t>
            </a:r>
            <a:endParaRPr/>
          </a:p>
        </p:txBody>
      </p:sp>
      <p:graphicFrame>
        <p:nvGraphicFramePr>
          <p:cNvPr id="55" name="Google Shape;55;p13"/>
          <p:cNvGraphicFramePr/>
          <p:nvPr/>
        </p:nvGraphicFramePr>
        <p:xfrm>
          <a:off x="576263" y="1017725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B56DA76-8842-4CF5-BA3B-0775C3941FC7}</a:tableStyleId>
              </a:tblPr>
              <a:tblGrid>
                <a:gridCol w="1343025"/>
                <a:gridCol w="1400175"/>
                <a:gridCol w="1838325"/>
                <a:gridCol w="1952625"/>
                <a:gridCol w="1457325"/>
              </a:tblGrid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pecie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_nam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cords With Denominator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eoplasia With Denominator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eoplasia Prevalenc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ustela putori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Ferre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0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6285714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Didelphis virginian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Virginia opossum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5555555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anthera onc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Jagua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4545454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Atelerix albiventri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Four-toed hedgehog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4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4489795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Elephas maxim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Asian elephan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4090909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etaurus brevicep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ygmy sugar glide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us muscul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mous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90243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an troglodyte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himpanze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846153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anthera unci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now leopard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636363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Lycaon pict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ape hunting dog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5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448275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 fontScale="90000"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Top 20 Second 10 Neoplasia</a:t>
            </a:r>
            <a:endParaRPr/>
          </a:p>
        </p:txBody>
      </p:sp>
      <p:graphicFrame>
        <p:nvGraphicFramePr>
          <p:cNvPr id="61" name="Google Shape;61;p14"/>
          <p:cNvGraphicFramePr/>
          <p:nvPr/>
        </p:nvGraphicFramePr>
        <p:xfrm>
          <a:off x="552450" y="1017725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B56DA76-8842-4CF5-BA3B-0775C3941FC7}</a:tableStyleId>
              </a:tblPr>
              <a:tblGrid>
                <a:gridCol w="1238250"/>
                <a:gridCol w="1552575"/>
                <a:gridCol w="1838325"/>
                <a:gridCol w="1952625"/>
                <a:gridCol w="1457325"/>
              </a:tblGrid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pecie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_nam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cords With Denominator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eoplasia With Denominator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eoplasia Prevalenc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attus norvegic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Typical ra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5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2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446327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anis lup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Gray wolf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333333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Varecia variegat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d/black ruffed lemu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333333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Vulpes zerd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Fennec fox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181818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apra hirc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Domestic goa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1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162393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Ursus maritim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olar bea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076923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uma concolo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ountain lion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043478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anthera pard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Leopard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Lama glam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Llam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941176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Lemur catt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ing-tailed lemu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9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842105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5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 fontScale="90000"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Bottom 20 First 10 Neoplasia</a:t>
            </a:r>
            <a:endParaRPr/>
          </a:p>
        </p:txBody>
      </p:sp>
      <p:graphicFrame>
        <p:nvGraphicFramePr>
          <p:cNvPr id="67" name="Google Shape;67;p15"/>
          <p:cNvGraphicFramePr/>
          <p:nvPr/>
        </p:nvGraphicFramePr>
        <p:xfrm>
          <a:off x="78000" y="1017725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B56DA76-8842-4CF5-BA3B-0775C3941FC7}</a:tableStyleId>
              </a:tblPr>
              <a:tblGrid>
                <a:gridCol w="1593025"/>
                <a:gridCol w="1388100"/>
                <a:gridCol w="1686200"/>
                <a:gridCol w="1788675"/>
                <a:gridCol w="1332175"/>
                <a:gridCol w="1155175"/>
              </a:tblGrid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pecie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_nam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cordsWithDenominator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eoplasiaWithDenominator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eoplasiaPrevalenc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tdErrorNeoplasi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Lemniscomys barbar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triped grass mous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13227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hocoena phocoen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porpois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147078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icrotus agresti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field vole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2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2700013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teropus rodricensi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odrigues fruit bat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2803688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Heterocephalus glabe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aked mole ra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4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13793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830454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Acrobates pygmaeu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Feathertail glider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3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5249857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aimiri boliviensi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Black-capped squirrel monkey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4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7149859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Delphinus delphi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dolphin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796053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ithecia pithecia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White-faced saki monkey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7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9245009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hrotopterus aurit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Vampire ba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208333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443375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1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 fontScale="90000"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Bottom 20 Second 10 Neoplasia</a:t>
            </a:r>
            <a:endParaRPr/>
          </a:p>
        </p:txBody>
      </p:sp>
      <p:graphicFrame>
        <p:nvGraphicFramePr>
          <p:cNvPr id="73" name="Google Shape;73;p16"/>
          <p:cNvGraphicFramePr/>
          <p:nvPr/>
        </p:nvGraphicFramePr>
        <p:xfrm>
          <a:off x="152400" y="1017825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B56DA76-8842-4CF5-BA3B-0775C3941FC7}</a:tableStyleId>
              </a:tblPr>
              <a:tblGrid>
                <a:gridCol w="1304200"/>
                <a:gridCol w="1787600"/>
                <a:gridCol w="1596075"/>
                <a:gridCol w="1696400"/>
                <a:gridCol w="1267725"/>
                <a:gridCol w="1103575"/>
              </a:tblGrid>
              <a:tr h="4007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pecie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_name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cordsWithDenominator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eoplasiaWithDenominator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eoplasiaPrevalence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tdErrorNeoplasia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4007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hyllostomus discolor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ale spear-nosed bat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3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085144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4007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crotus californicu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alifornia leaf-nosed bat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3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085144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4007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ciurus carolinensi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Grey squirrel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1821789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68800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ico Argentatu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ilvery marmoset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236068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68800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cropus eugenii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Tammar wallaby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243902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561737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68800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apra nubian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ubian ibex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285714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690308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68800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aguinus imperato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Emperor tamarin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285714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690308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68800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ebuella pygmae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ygmy marmose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312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2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68800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Eidolon helvum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traw-colored fruit ba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322580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79605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68800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uscardinus avellanari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dormous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5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384615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386750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7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17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 fontScale="90000"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Top 20 First 10 </a:t>
            </a:r>
            <a:r>
              <a:rPr lang="en"/>
              <a:t>Malignancy</a:t>
            </a:r>
            <a:endParaRPr/>
          </a:p>
        </p:txBody>
      </p:sp>
      <p:graphicFrame>
        <p:nvGraphicFramePr>
          <p:cNvPr id="79" name="Google Shape;79;p17"/>
          <p:cNvGraphicFramePr/>
          <p:nvPr/>
        </p:nvGraphicFramePr>
        <p:xfrm>
          <a:off x="538163" y="1017725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B56DA76-8842-4CF5-BA3B-0775C3941FC7}</a:tableStyleId>
              </a:tblPr>
              <a:tblGrid>
                <a:gridCol w="1343025"/>
                <a:gridCol w="1400175"/>
                <a:gridCol w="1838325"/>
                <a:gridCol w="1102850"/>
                <a:gridCol w="830725"/>
                <a:gridCol w="1552575"/>
              </a:tblGrid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pecie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_nam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cords With Denominator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cy Known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cy Prevalenc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Didelphis virginian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Virginia opossum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5185185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ustela putori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Ferre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0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4095238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anthera onc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Jagua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4090909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Atelerix albiventri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Four-toed hedgehog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4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5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53741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anthera unci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now leopard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03030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etaurus brevicep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ygmy sugar glide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Vulpes zerd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Fennec fox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0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727272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us muscul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mous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682926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uma concolo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ountain lion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608695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anis lup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Gray wolf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8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 fontScale="90000"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Top 20 Second 10 Malignancy</a:t>
            </a:r>
            <a:endParaRPr/>
          </a:p>
        </p:txBody>
      </p:sp>
      <p:graphicFrame>
        <p:nvGraphicFramePr>
          <p:cNvPr id="85" name="Google Shape;85;p18"/>
          <p:cNvGraphicFramePr/>
          <p:nvPr/>
        </p:nvGraphicFramePr>
        <p:xfrm>
          <a:off x="338138" y="1017725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B56DA76-8842-4CF5-BA3B-0775C3941FC7}</a:tableStyleId>
              </a:tblPr>
              <a:tblGrid>
                <a:gridCol w="1590675"/>
                <a:gridCol w="1552575"/>
                <a:gridCol w="1838325"/>
                <a:gridCol w="1087375"/>
                <a:gridCol w="846200"/>
                <a:gridCol w="1552575"/>
              </a:tblGrid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pecie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_nam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cords With Denominator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cy Known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t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cy Prevalence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hascolarctos cinere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Koal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8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Lemur catt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ing-tailed lemu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9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315789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Varecia variegata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d/black ruffed lemu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291666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Lycaon pict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ape hunting dog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5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241379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Ursus maritim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olar bea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923076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Didelphis marsupiali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Oppossum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884058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Ovis arie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heep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8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839080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anthera tigri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White bengal tiger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2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690140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ynomys ludovician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Gunnison prairie dog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37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9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3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678832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Octodon degus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Degu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5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1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6</a:t>
                      </a:r>
                      <a:endParaRPr sz="1200"/>
                    </a:p>
                  </a:txBody>
                  <a:tcPr marT="9525" marB="91425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9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19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 fontScale="90000"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Bottom 20 First 10 Malignancy</a:t>
            </a:r>
            <a:endParaRPr/>
          </a:p>
        </p:txBody>
      </p:sp>
      <p:graphicFrame>
        <p:nvGraphicFramePr>
          <p:cNvPr id="91" name="Google Shape;91;p19"/>
          <p:cNvGraphicFramePr/>
          <p:nvPr/>
        </p:nvGraphicFramePr>
        <p:xfrm>
          <a:off x="235800" y="1017725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B56DA76-8842-4CF5-BA3B-0775C3941FC7}</a:tableStyleId>
              </a:tblPr>
              <a:tblGrid>
                <a:gridCol w="1640000"/>
                <a:gridCol w="1330225"/>
                <a:gridCol w="962975"/>
                <a:gridCol w="871900"/>
                <a:gridCol w="1012800"/>
                <a:gridCol w="1252400"/>
                <a:gridCol w="1676350"/>
              </a:tblGrid>
              <a:tr h="308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pecies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_name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cords With Denominators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cy Known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t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cy Prevalence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tdErrorMal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5667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Heterocephalus glaber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aked mole rat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45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0689655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08304548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08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Lemniscomys barbarus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triped grass mouse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8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132277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5667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hocoena phocoena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porpoise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76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1470787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783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ebuella pygmaea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ygmy marmoset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4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25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5667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icrotus agrestis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field vole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2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2700013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5667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teropus rodricensis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odrigues fruit bat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61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2803688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5667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uscardinus avellanarius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dormouse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52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3867505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5667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hrotopterus auritus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Vampire bat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8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4433757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5667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Tragelaphus strepsiceros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Kudu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8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4433757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5667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Acrobates pygmaeus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Feathertail glider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43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5249857</a:t>
                      </a:r>
                      <a:endParaRPr sz="1200"/>
                    </a:p>
                  </a:txBody>
                  <a:tcPr marT="0" marB="0" marR="0" marL="0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5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20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 fontScale="90000"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Bottom 20 Second 10 Malignancy</a:t>
            </a:r>
            <a:endParaRPr/>
          </a:p>
        </p:txBody>
      </p:sp>
      <p:graphicFrame>
        <p:nvGraphicFramePr>
          <p:cNvPr id="97" name="Google Shape;97;p20"/>
          <p:cNvGraphicFramePr/>
          <p:nvPr/>
        </p:nvGraphicFramePr>
        <p:xfrm>
          <a:off x="200875" y="947150"/>
          <a:ext cx="3000000" cy="3000000"/>
        </p:xfrm>
        <a:graphic>
          <a:graphicData uri="http://schemas.openxmlformats.org/drawingml/2006/table">
            <a:tbl>
              <a:tblPr>
                <a:noFill/>
                <a:tableStyleId>{CB56DA76-8842-4CF5-BA3B-0775C3941FC7}</a:tableStyleId>
              </a:tblPr>
              <a:tblGrid>
                <a:gridCol w="1342250"/>
                <a:gridCol w="1841050"/>
                <a:gridCol w="1650600"/>
                <a:gridCol w="1124575"/>
                <a:gridCol w="607625"/>
                <a:gridCol w="1396650"/>
                <a:gridCol w="743675"/>
              </a:tblGrid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pecie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_name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Records With Denominator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cy Known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t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lignancy Prevalence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td Error Mal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apra nubiana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Nubian ibex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5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6903085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aimiri boliviensi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Black-capped squirrel monkey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4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7149859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Delphinus delphi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ommon dolphin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796053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Ovis canadensi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Big horn sheep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3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8257419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ithecia pithecia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White-faced saki monkey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7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19245009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caca nigra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ulawesi crested macaque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5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hyllostomus discolor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Pale spear-nosed bat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3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085144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acrotus californicu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California leaf-nosed bat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3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085144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ciurus carolinensi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Grey squirrel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1821789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Mico Argentatus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Silvery marmoset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2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1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200"/>
                        <a:t>0.2236068</a:t>
                      </a:r>
                      <a:endParaRPr sz="1200"/>
                    </a:p>
                  </a:txBody>
                  <a:tcPr marT="0" marB="0" marR="9525" marL="9525" anchor="b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